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7" d="100"/>
          <a:sy n="47" d="100"/>
        </p:scale>
        <p:origin x="216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4570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1283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303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1074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085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414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900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228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7292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63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4558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829B2-3581-4421-BED0-7E7A870A5736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24521-B261-4769-9CB6-2AC2AF8097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9644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DD165FA5-A422-468A-B246-91C8CD83EDA5}"/>
              </a:ext>
            </a:extLst>
          </p:cNvPr>
          <p:cNvGrpSpPr>
            <a:grpSpLocks noChangeAspect="1"/>
          </p:cNvGrpSpPr>
          <p:nvPr/>
        </p:nvGrpSpPr>
        <p:grpSpPr>
          <a:xfrm>
            <a:off x="539993" y="345745"/>
            <a:ext cx="5769007" cy="8668597"/>
            <a:chOff x="54941" y="264801"/>
            <a:chExt cx="6240052" cy="9376399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5D5C5828-030F-4415-BE40-D135C988261A}"/>
                </a:ext>
              </a:extLst>
            </p:cNvPr>
            <p:cNvGrpSpPr/>
            <p:nvPr/>
          </p:nvGrpSpPr>
          <p:grpSpPr>
            <a:xfrm>
              <a:off x="563007" y="264801"/>
              <a:ext cx="5731986" cy="9376399"/>
              <a:chOff x="291825" y="660932"/>
              <a:chExt cx="6356626" cy="10398186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BD96D591-C023-4B25-A8FE-A314413167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8144"/>
              <a:stretch/>
            </p:blipFill>
            <p:spPr>
              <a:xfrm>
                <a:off x="301350" y="4741308"/>
                <a:ext cx="6299475" cy="1680072"/>
              </a:xfrm>
              <a:prstGeom prst="rect">
                <a:avLst/>
              </a:prstGeom>
            </p:spPr>
          </p:pic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D53B8796-3A96-449A-A6FD-44AF394CCF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0875" y="3477825"/>
                <a:ext cx="2700000" cy="1334438"/>
              </a:xfrm>
              <a:prstGeom prst="rect">
                <a:avLst/>
              </a:prstGeom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0B80A20-CCCE-46BC-81F1-8B610840FC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91825" y="2004634"/>
                <a:ext cx="4860000" cy="1511293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36FF74F6-8EFE-4062-8087-3B72C6E593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91825" y="660932"/>
                <a:ext cx="5040000" cy="1372277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983986D1-FD8A-48CD-B44E-832AEB749B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29925" y="6359904"/>
                <a:ext cx="5040000" cy="1513230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4CF4C5C2-256C-4B1E-BAA9-6005B56F33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29925" y="7773626"/>
                <a:ext cx="4860000" cy="1667531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CB5772B2-302F-4161-B69B-97E0DDA588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r="7866"/>
              <a:stretch/>
            </p:blipFill>
            <p:spPr>
              <a:xfrm>
                <a:off x="329926" y="9394233"/>
                <a:ext cx="6318525" cy="1664885"/>
              </a:xfrm>
              <a:prstGeom prst="rect">
                <a:avLst/>
              </a:prstGeom>
            </p:spPr>
          </p:pic>
        </p:grp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096380FD-228A-4A90-9AFD-7655513DA0FC}"/>
                </a:ext>
              </a:extLst>
            </p:cNvPr>
            <p:cNvGrpSpPr/>
            <p:nvPr/>
          </p:nvGrpSpPr>
          <p:grpSpPr>
            <a:xfrm>
              <a:off x="54941" y="681376"/>
              <a:ext cx="695508" cy="8224690"/>
              <a:chOff x="54941" y="681376"/>
              <a:chExt cx="695508" cy="8224690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CDF4BEB-FCF8-466A-8D3C-BAE9B2E8E936}"/>
                  </a:ext>
                </a:extLst>
              </p:cNvPr>
              <p:cNvSpPr txBox="1"/>
              <p:nvPr/>
            </p:nvSpPr>
            <p:spPr>
              <a:xfrm>
                <a:off x="106050" y="681376"/>
                <a:ext cx="575999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B. </a:t>
                </a:r>
                <a:r>
                  <a:rPr lang="en-US" altLang="zh-CN" sz="634" b="1" i="1" dirty="0" err="1">
                    <a:latin typeface="Times New Roman" panose="02020603050405020304" pitchFamily="18" charset="0"/>
                    <a:ea typeface="等线" panose="02010600030101010101" pitchFamily="2" charset="-122"/>
                  </a:rPr>
                  <a:t>hispida</a:t>
                </a:r>
                <a:endParaRPr lang="zh-CN" altLang="en-US" sz="634" b="1" dirty="0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D75C055A-038B-4FDB-B564-6A3EE07EFCE3}"/>
                  </a:ext>
                </a:extLst>
              </p:cNvPr>
              <p:cNvSpPr txBox="1"/>
              <p:nvPr/>
            </p:nvSpPr>
            <p:spPr>
              <a:xfrm>
                <a:off x="54941" y="1877980"/>
                <a:ext cx="695508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L. siceraria</a:t>
                </a:r>
                <a:endParaRPr lang="zh-CN" altLang="en-US" sz="634" b="1" dirty="0"/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68D74CB3-CB8F-45A6-932F-34BEDEF69821}"/>
                  </a:ext>
                </a:extLst>
              </p:cNvPr>
              <p:cNvSpPr txBox="1"/>
              <p:nvPr/>
            </p:nvSpPr>
            <p:spPr>
              <a:xfrm>
                <a:off x="125050" y="3180640"/>
                <a:ext cx="576000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C. sativus</a:t>
                </a:r>
                <a:endParaRPr lang="zh-CN" altLang="en-US" sz="634" b="1" dirty="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4A53C561-F9C1-4B21-BF63-B37357DD38CC}"/>
                  </a:ext>
                </a:extLst>
              </p:cNvPr>
              <p:cNvSpPr txBox="1"/>
              <p:nvPr/>
            </p:nvSpPr>
            <p:spPr>
              <a:xfrm>
                <a:off x="97525" y="4446181"/>
                <a:ext cx="605022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C. maxima</a:t>
                </a:r>
                <a:endParaRPr lang="zh-CN" altLang="en-US" sz="634" b="1" dirty="0"/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DBFF48CF-FDE5-4C95-BE78-58FE5C5199A2}"/>
                  </a:ext>
                </a:extLst>
              </p:cNvPr>
              <p:cNvSpPr txBox="1"/>
              <p:nvPr/>
            </p:nvSpPr>
            <p:spPr>
              <a:xfrm>
                <a:off x="163269" y="5942265"/>
                <a:ext cx="534937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C. melon</a:t>
                </a:r>
                <a:endParaRPr lang="zh-CN" altLang="en-US" sz="634" b="1" dirty="0"/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90A51BE8-7837-44F6-9053-2DB5FC256A93}"/>
                  </a:ext>
                </a:extLst>
              </p:cNvPr>
              <p:cNvSpPr txBox="1"/>
              <p:nvPr/>
            </p:nvSpPr>
            <p:spPr>
              <a:xfrm>
                <a:off x="135972" y="7207805"/>
                <a:ext cx="576000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C. </a:t>
                </a:r>
                <a:r>
                  <a:rPr lang="en-US" altLang="zh-CN" sz="634" b="1" i="1" dirty="0" err="1">
                    <a:latin typeface="Times New Roman" panose="02020603050405020304" pitchFamily="18" charset="0"/>
                    <a:ea typeface="等线" panose="02010600030101010101" pitchFamily="2" charset="-122"/>
                  </a:rPr>
                  <a:t>lanatus</a:t>
                </a:r>
                <a:endParaRPr lang="zh-CN" altLang="en-US" sz="634" b="1" dirty="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461D9DE0-E671-4583-9504-ADBBC13B721C}"/>
                  </a:ext>
                </a:extLst>
              </p:cNvPr>
              <p:cNvSpPr txBox="1"/>
              <p:nvPr/>
            </p:nvSpPr>
            <p:spPr>
              <a:xfrm>
                <a:off x="232891" y="8700634"/>
                <a:ext cx="474602" cy="2054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34" b="1" i="1" dirty="0">
                    <a:latin typeface="Times New Roman" panose="02020603050405020304" pitchFamily="18" charset="0"/>
                    <a:ea typeface="等线" panose="02010600030101010101" pitchFamily="2" charset="-122"/>
                  </a:rPr>
                  <a:t>C. pepo</a:t>
                </a:r>
                <a:endParaRPr lang="zh-CN" altLang="en-US" sz="634" b="1" dirty="0"/>
              </a:p>
            </p:txBody>
          </p:sp>
        </p:grpSp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3EF0874D-0B81-4D8C-B5C6-AE313AF49F83}"/>
              </a:ext>
            </a:extLst>
          </p:cNvPr>
          <p:cNvSpPr txBox="1"/>
          <p:nvPr/>
        </p:nvSpPr>
        <p:spPr>
          <a:xfrm>
            <a:off x="729000" y="9253182"/>
            <a:ext cx="540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al locations of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BBY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the genome of seven cucurbit species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653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45">
            <a:extLst>
              <a:ext uri="{FF2B5EF4-FFF2-40B4-BE49-F238E27FC236}">
                <a16:creationId xmlns:a16="http://schemas.microsoft.com/office/drawing/2014/main" id="{B7C583D8-F818-490A-8420-F8CBBAA664E6}"/>
              </a:ext>
            </a:extLst>
          </p:cNvPr>
          <p:cNvGrpSpPr>
            <a:grpSpLocks/>
          </p:cNvGrpSpPr>
          <p:nvPr/>
        </p:nvGrpSpPr>
        <p:grpSpPr>
          <a:xfrm>
            <a:off x="1372895" y="498000"/>
            <a:ext cx="4112210" cy="7632000"/>
            <a:chOff x="1585292" y="252456"/>
            <a:chExt cx="4978605" cy="10787233"/>
          </a:xfrm>
        </p:grpSpPr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CD37AEE1-BE5A-434B-A1E7-429ADDEBF570}"/>
                </a:ext>
              </a:extLst>
            </p:cNvPr>
            <p:cNvGrpSpPr/>
            <p:nvPr/>
          </p:nvGrpSpPr>
          <p:grpSpPr>
            <a:xfrm>
              <a:off x="2014709" y="252456"/>
              <a:ext cx="4549188" cy="10787233"/>
              <a:chOff x="2014709" y="252456"/>
              <a:chExt cx="4549188" cy="1078723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4B0805C-5A5F-4008-B08E-CE741DCB2E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485"/>
              <a:stretch/>
            </p:blipFill>
            <p:spPr>
              <a:xfrm>
                <a:off x="2021841" y="252456"/>
                <a:ext cx="4542056" cy="108000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933C0455-4CEC-468F-98F8-29970CBE22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485"/>
              <a:stretch/>
            </p:blipFill>
            <p:spPr>
              <a:xfrm>
                <a:off x="2021840" y="1320954"/>
                <a:ext cx="4542056" cy="1080000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17651CED-07CF-4735-B0B3-E20E87355F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252"/>
              <a:stretch/>
            </p:blipFill>
            <p:spPr>
              <a:xfrm>
                <a:off x="2021048" y="2412456"/>
                <a:ext cx="3504894" cy="108000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2EE4ABE5-5DBB-48C3-BB74-96CAD34CCA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593"/>
              <a:stretch/>
            </p:blipFill>
            <p:spPr>
              <a:xfrm>
                <a:off x="2021048" y="3505257"/>
                <a:ext cx="1988337" cy="1080000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B1ED0164-C1EC-448D-9EDF-291F43133EF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593"/>
              <a:stretch/>
            </p:blipFill>
            <p:spPr>
              <a:xfrm>
                <a:off x="2014710" y="4598058"/>
                <a:ext cx="3517569" cy="1080000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63384F3C-078C-4236-AAA4-E02B981FD8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71"/>
              <a:stretch/>
            </p:blipFill>
            <p:spPr>
              <a:xfrm>
                <a:off x="2014710" y="5666556"/>
                <a:ext cx="2457349" cy="1080000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976E1C0F-0ED7-4820-8970-1CF4EC5C03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527"/>
              <a:stretch/>
            </p:blipFill>
            <p:spPr>
              <a:xfrm>
                <a:off x="2014710" y="6758058"/>
                <a:ext cx="3940021" cy="1080000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56F8203B-BA71-4044-900D-50447863C4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71"/>
              <a:stretch/>
            </p:blipFill>
            <p:spPr>
              <a:xfrm>
                <a:off x="2014710" y="7826556"/>
                <a:ext cx="2609713" cy="10800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395622B7-5CB0-4858-96B5-5F6E33884F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71"/>
              <a:stretch/>
            </p:blipFill>
            <p:spPr>
              <a:xfrm>
                <a:off x="2014709" y="8895054"/>
                <a:ext cx="2609713" cy="1080000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99229C9A-960D-457D-8AB3-49C1873E04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251"/>
              <a:stretch/>
            </p:blipFill>
            <p:spPr>
              <a:xfrm>
                <a:off x="2014709" y="9959689"/>
                <a:ext cx="4530967" cy="1080000"/>
              </a:xfrm>
              <a:prstGeom prst="rect">
                <a:avLst/>
              </a:prstGeom>
            </p:spPr>
          </p:pic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0D87747F-ABBF-42C6-AEEA-B11CD9BF7A06}"/>
                </a:ext>
              </a:extLst>
            </p:cNvPr>
            <p:cNvGrpSpPr/>
            <p:nvPr/>
          </p:nvGrpSpPr>
          <p:grpSpPr>
            <a:xfrm>
              <a:off x="1585292" y="626165"/>
              <a:ext cx="735496" cy="10044831"/>
              <a:chOff x="1585292" y="626165"/>
              <a:chExt cx="735496" cy="10044831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0DB0FBC2-E2EF-4A2E-9BC1-D3124F008757}"/>
                  </a:ext>
                </a:extLst>
              </p:cNvPr>
              <p:cNvSpPr txBox="1"/>
              <p:nvPr/>
            </p:nvSpPr>
            <p:spPr>
              <a:xfrm>
                <a:off x="1585292" y="626165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1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9F087A2C-0E68-435E-8FD0-7DD3495A1BB8}"/>
                  </a:ext>
                </a:extLst>
              </p:cNvPr>
              <p:cNvSpPr txBox="1"/>
              <p:nvPr/>
            </p:nvSpPr>
            <p:spPr>
              <a:xfrm>
                <a:off x="1585292" y="2863212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3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878561E9-C304-4537-B3B7-8F2B69E7BD04}"/>
                  </a:ext>
                </a:extLst>
              </p:cNvPr>
              <p:cNvSpPr txBox="1"/>
              <p:nvPr/>
            </p:nvSpPr>
            <p:spPr>
              <a:xfrm>
                <a:off x="1585292" y="1694663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2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8E4C570-E1BB-44CA-8C45-A7A36FC6B4FB}"/>
                  </a:ext>
                </a:extLst>
              </p:cNvPr>
              <p:cNvSpPr txBox="1"/>
              <p:nvPr/>
            </p:nvSpPr>
            <p:spPr>
              <a:xfrm>
                <a:off x="1585292" y="3973446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4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145A207-A2FA-4699-8E63-997CB836B5DB}"/>
                  </a:ext>
                </a:extLst>
              </p:cNvPr>
              <p:cNvSpPr txBox="1"/>
              <p:nvPr/>
            </p:nvSpPr>
            <p:spPr>
              <a:xfrm>
                <a:off x="1585292" y="5047826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5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C269BE52-5E75-478C-AE1E-A5D61EBABFDB}"/>
                  </a:ext>
                </a:extLst>
              </p:cNvPr>
              <p:cNvSpPr txBox="1"/>
              <p:nvPr/>
            </p:nvSpPr>
            <p:spPr>
              <a:xfrm>
                <a:off x="1585292" y="6129263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6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26264B0D-50D1-478F-B05B-68F65E817F85}"/>
                  </a:ext>
                </a:extLst>
              </p:cNvPr>
              <p:cNvSpPr txBox="1"/>
              <p:nvPr/>
            </p:nvSpPr>
            <p:spPr>
              <a:xfrm>
                <a:off x="1585292" y="7209264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7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31356D13-3928-44A6-B3C8-1FF86D99E1B7}"/>
                  </a:ext>
                </a:extLst>
              </p:cNvPr>
              <p:cNvSpPr txBox="1"/>
              <p:nvPr/>
            </p:nvSpPr>
            <p:spPr>
              <a:xfrm>
                <a:off x="1585292" y="8273898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8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6B609C9F-1336-40CD-88EA-D3BB96B87EEE}"/>
                  </a:ext>
                </a:extLst>
              </p:cNvPr>
              <p:cNvSpPr txBox="1"/>
              <p:nvPr/>
            </p:nvSpPr>
            <p:spPr>
              <a:xfrm>
                <a:off x="1585292" y="9368814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9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97A33B25-F3B6-4CAF-86F1-2A8ED61608BF}"/>
                  </a:ext>
                </a:extLst>
              </p:cNvPr>
              <p:cNvSpPr txBox="1"/>
              <p:nvPr/>
            </p:nvSpPr>
            <p:spPr>
              <a:xfrm>
                <a:off x="1585292" y="10433449"/>
                <a:ext cx="735496" cy="237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7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tif 10</a:t>
                </a:r>
                <a:endParaRPr lang="zh-CN" altLang="en-US" sz="67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5" name="文本框 34">
            <a:extLst>
              <a:ext uri="{FF2B5EF4-FFF2-40B4-BE49-F238E27FC236}">
                <a16:creationId xmlns:a16="http://schemas.microsoft.com/office/drawing/2014/main" id="{DC911A77-D8F9-4FEE-9C0A-AF1E460D0BA6}"/>
              </a:ext>
            </a:extLst>
          </p:cNvPr>
          <p:cNvSpPr txBox="1"/>
          <p:nvPr/>
        </p:nvSpPr>
        <p:spPr>
          <a:xfrm>
            <a:off x="1372895" y="8483123"/>
            <a:ext cx="418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conserved motifs in YABBY proteins of eight cucurbit species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408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8</TotalTime>
  <Words>72</Words>
  <Application>Microsoft Office PowerPoint</Application>
  <PresentationFormat>A4 纸张(210x297 毫米)</PresentationFormat>
  <Paragraphs>1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春花</dc:creator>
  <cp:lastModifiedBy>yin shuai</cp:lastModifiedBy>
  <cp:revision>16</cp:revision>
  <dcterms:created xsi:type="dcterms:W3CDTF">2021-11-16T02:21:01Z</dcterms:created>
  <dcterms:modified xsi:type="dcterms:W3CDTF">2022-02-22T14:30:21Z</dcterms:modified>
</cp:coreProperties>
</file>